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74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0717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0105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4903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727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841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7189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04807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531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9346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4705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5888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E4A75F-FC5B-4B5D-87C1-731441217248}" type="datetimeFigureOut">
              <a:rPr lang="fr-FR" smtClean="0"/>
              <a:t>29/10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E84C-6FB4-4ACD-8E1C-BAE8D4AB6BA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8450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Mes documents\VPS13D\WBFibro300519\Mb2-cpx-rougeNB3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5" t="-756" r="17729" b="9409"/>
          <a:stretch/>
        </p:blipFill>
        <p:spPr bwMode="auto">
          <a:xfrm>
            <a:off x="1008857" y="943137"/>
            <a:ext cx="4225510" cy="327587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ZoneTexte 4"/>
          <p:cNvSpPr txBox="1"/>
          <p:nvPr/>
        </p:nvSpPr>
        <p:spPr>
          <a:xfrm rot="18493840">
            <a:off x="3035394" y="594468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trl2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 rot="18493840">
            <a:off x="1568135" y="586913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trl1-1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 rot="18493840">
            <a:off x="3437588" y="500658"/>
            <a:ext cx="6944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-1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 rot="18493840">
            <a:off x="1961556" y="586913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trl1-2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/>
          <p:cNvSpPr txBox="1"/>
          <p:nvPr/>
        </p:nvSpPr>
        <p:spPr>
          <a:xfrm rot="18493840">
            <a:off x="2467190" y="586913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trl1-3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 rot="18493840">
            <a:off x="3882380" y="500658"/>
            <a:ext cx="6944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-2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 rot="18493840">
            <a:off x="4392344" y="532123"/>
            <a:ext cx="6944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-3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 rot="18493840">
            <a:off x="4818483" y="529361"/>
            <a:ext cx="6944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-4</a:t>
            </a:r>
            <a:endParaRPr lang="fr-FR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5285061" y="5613494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ctine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5271678" y="5941999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VDAC1</a:t>
            </a:r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8" name="Picture 4" descr="D:\Mes documents\VPS13D\wb160419\cpxmb1actineb-VDAC1b .tif.tif (green)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91" t="13626" r="19177" b="-612"/>
          <a:stretch/>
        </p:blipFill>
        <p:spPr bwMode="auto">
          <a:xfrm>
            <a:off x="1021327" y="4303111"/>
            <a:ext cx="4229153" cy="251026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ZoneTexte 25"/>
          <p:cNvSpPr txBox="1"/>
          <p:nvPr/>
        </p:nvSpPr>
        <p:spPr>
          <a:xfrm>
            <a:off x="5755320" y="2289217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Cpx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V</a:t>
            </a:r>
          </a:p>
        </p:txBody>
      </p:sp>
      <p:sp>
        <p:nvSpPr>
          <p:cNvPr id="27" name="ZoneTexte 26"/>
          <p:cNvSpPr txBox="1"/>
          <p:nvPr/>
        </p:nvSpPr>
        <p:spPr>
          <a:xfrm>
            <a:off x="5755320" y="2450814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Cpx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III</a:t>
            </a:r>
          </a:p>
        </p:txBody>
      </p:sp>
      <p:sp>
        <p:nvSpPr>
          <p:cNvPr id="28" name="ZoneTexte 27"/>
          <p:cNvSpPr txBox="1"/>
          <p:nvPr/>
        </p:nvSpPr>
        <p:spPr>
          <a:xfrm>
            <a:off x="5809488" y="3266945"/>
            <a:ext cx="6400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Cpx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IV</a:t>
            </a:r>
          </a:p>
        </p:txBody>
      </p:sp>
      <p:sp>
        <p:nvSpPr>
          <p:cNvPr id="29" name="ZoneTexte 28"/>
          <p:cNvSpPr txBox="1"/>
          <p:nvPr/>
        </p:nvSpPr>
        <p:spPr>
          <a:xfrm>
            <a:off x="5787381" y="2965555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Cpx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II</a:t>
            </a:r>
          </a:p>
        </p:txBody>
      </p:sp>
      <p:sp>
        <p:nvSpPr>
          <p:cNvPr id="30" name="ZoneTexte 29"/>
          <p:cNvSpPr txBox="1"/>
          <p:nvPr/>
        </p:nvSpPr>
        <p:spPr>
          <a:xfrm>
            <a:off x="5812471" y="3415821"/>
            <a:ext cx="5180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Cpx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I</a:t>
            </a:r>
          </a:p>
        </p:txBody>
      </p:sp>
      <p:sp>
        <p:nvSpPr>
          <p:cNvPr id="31" name="ZoneTexte 30"/>
          <p:cNvSpPr txBox="1"/>
          <p:nvPr/>
        </p:nvSpPr>
        <p:spPr>
          <a:xfrm>
            <a:off x="5230260" y="2289217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5230260" y="2450814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5281319" y="3266945"/>
            <a:ext cx="5489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2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5234367" y="2965555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5258507" y="3415821"/>
            <a:ext cx="5460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8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008953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30</Words>
  <Application>Microsoft Office PowerPoint</Application>
  <PresentationFormat>Affichage à l'écran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Universite de Bordeaux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urand Christelle</dc:creator>
  <cp:lastModifiedBy>Durand Christelle</cp:lastModifiedBy>
  <cp:revision>3</cp:revision>
  <dcterms:created xsi:type="dcterms:W3CDTF">2019-07-04T11:36:06Z</dcterms:created>
  <dcterms:modified xsi:type="dcterms:W3CDTF">2021-10-29T10:01:34Z</dcterms:modified>
</cp:coreProperties>
</file>